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8034E78-7F5D-4C2E-B375-FC64B27BC917}" styleName="Dunkle Formatvorlag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749" autoAdjust="0"/>
    <p:restoredTop sz="94660"/>
  </p:normalViewPr>
  <p:slideViewPr>
    <p:cSldViewPr snapToGrid="0">
      <p:cViewPr>
        <p:scale>
          <a:sx n="148" d="100"/>
          <a:sy n="148" d="100"/>
        </p:scale>
        <p:origin x="504" y="10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5DB0FFFA-8DA6-4B7F-B00E-BC8DB857AE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="" xmlns:a16="http://schemas.microsoft.com/office/drawing/2014/main" id="{C6B26BD0-4834-4AA9-A855-08B5022D8E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78B3DC1B-824F-4FD9-A890-84D42FEC6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29A98747-EE57-46D5-B576-478BD25FA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969A95D1-4786-4708-851F-097E3BCD4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9457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5A23B27B-9E35-4A49-97A3-C6F93EC34C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="" xmlns:a16="http://schemas.microsoft.com/office/drawing/2014/main" id="{9CF8F601-41BD-470A-861C-669C8FD81E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223E931C-13D7-496A-B9AB-E9A4B47C84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73CE0E74-ED5E-461B-B8DF-9CEF21E8D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057E89E2-03CA-4E9B-89D8-60CF853045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2136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="" xmlns:a16="http://schemas.microsoft.com/office/drawing/2014/main" id="{B577B004-1A97-4C49-96B2-7C6197C853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="" xmlns:a16="http://schemas.microsoft.com/office/drawing/2014/main" id="{D4AA5CCE-4181-4F5C-ACE3-C30EF73CA5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0357127C-97C9-437E-9188-3827BBB203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94D78910-5C3F-493C-9A34-5B1A9E77B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DAB5F139-001A-4FDA-B8EA-2F9B963F0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1865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845B7FC3-2680-4AE5-9597-0294A7C1CB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="" xmlns:a16="http://schemas.microsoft.com/office/drawing/2014/main" id="{A21C6102-D45C-45A2-9211-3AEA2DC52B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6D03DDF8-C460-496B-924D-52EF6EDAE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7BE7F172-0754-41A3-B69A-33AABDACE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FBCCA9D7-1AC8-4327-ADE5-11690F6BE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1713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A2172337-3463-4A83-9C13-CBD07BE16D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="" xmlns:a16="http://schemas.microsoft.com/office/drawing/2014/main" id="{4EFF3177-075F-47D4-B022-F36EC500C7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6A295249-24FD-4168-9645-6BF4B3F5B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C64497CE-3EFF-4D71-B184-BCCDB2252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FB275E2E-DD79-49E6-9B8F-1A60C3768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2032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853E3A73-30FB-44A5-83E3-E4019C66CA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="" xmlns:a16="http://schemas.microsoft.com/office/drawing/2014/main" id="{D8060ECA-C6C3-467D-BE7D-DBF72991A4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="" xmlns:a16="http://schemas.microsoft.com/office/drawing/2014/main" id="{6CE4E87E-DDEE-4BA4-95AD-8C407445AA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="" xmlns:a16="http://schemas.microsoft.com/office/drawing/2014/main" id="{11DFCBCB-5749-492D-A7BB-707F4861C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="" xmlns:a16="http://schemas.microsoft.com/office/drawing/2014/main" id="{E72C25CF-FB13-4A40-9969-171117AC2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="" xmlns:a16="http://schemas.microsoft.com/office/drawing/2014/main" id="{0357324D-03E7-4356-9897-9446612B4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4543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9E224298-0AC7-4745-A751-45C73FB029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="" xmlns:a16="http://schemas.microsoft.com/office/drawing/2014/main" id="{078132A8-DE6D-43BC-9001-359D458A86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="" xmlns:a16="http://schemas.microsoft.com/office/drawing/2014/main" id="{2BB57B94-EA31-4C48-BBF4-31D2C0519C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="" xmlns:a16="http://schemas.microsoft.com/office/drawing/2014/main" id="{CBD098D6-E27A-4474-95F3-EEBA44E93B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="" xmlns:a16="http://schemas.microsoft.com/office/drawing/2014/main" id="{867015AC-DD06-422A-9289-21D4FCD5B8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="" xmlns:a16="http://schemas.microsoft.com/office/drawing/2014/main" id="{F8A796CE-601C-44D8-8B50-8D53A5521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="" xmlns:a16="http://schemas.microsoft.com/office/drawing/2014/main" id="{A2C5306E-96F8-45FF-B729-71680B7376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="" xmlns:a16="http://schemas.microsoft.com/office/drawing/2014/main" id="{826A7751-8763-4301-92AA-133441739A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5244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382A2770-22B9-4179-B4BB-E0CEA01277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="" xmlns:a16="http://schemas.microsoft.com/office/drawing/2014/main" id="{510A8E7C-B80B-4792-8B45-754C8A984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="" xmlns:a16="http://schemas.microsoft.com/office/drawing/2014/main" id="{F16F4EE8-F4D2-439E-B427-DA5D67CEB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="" xmlns:a16="http://schemas.microsoft.com/office/drawing/2014/main" id="{2C7C751D-5D52-4838-BBC6-01500B307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1238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="" xmlns:a16="http://schemas.microsoft.com/office/drawing/2014/main" id="{394CB2A7-0E62-4640-A518-CBD623DE7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="" xmlns:a16="http://schemas.microsoft.com/office/drawing/2014/main" id="{A85C4E40-0A9D-4D44-B572-7F7D462D8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="" xmlns:a16="http://schemas.microsoft.com/office/drawing/2014/main" id="{84363909-463A-43F0-B358-EFC83371F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4588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2D500C56-11F8-4E97-A8C7-8AAE384C55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="" xmlns:a16="http://schemas.microsoft.com/office/drawing/2014/main" id="{7149B7AD-AB1E-4086-B791-4C6E0B8BC9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="" xmlns:a16="http://schemas.microsoft.com/office/drawing/2014/main" id="{6E005B94-A581-4247-B2D1-97033BF442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="" xmlns:a16="http://schemas.microsoft.com/office/drawing/2014/main" id="{9B221D55-DCC7-4E97-AEC6-9477C23C9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="" xmlns:a16="http://schemas.microsoft.com/office/drawing/2014/main" id="{0AA7F9E8-5C51-4EA1-A189-AA4E92A67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="" xmlns:a16="http://schemas.microsoft.com/office/drawing/2014/main" id="{E8721185-4BC5-4AF5-BCE7-2D8757B27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2629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="" xmlns:a16="http://schemas.microsoft.com/office/drawing/2014/main" id="{4A83E2FD-D285-4251-AF65-6B66D60AAA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="" xmlns:a16="http://schemas.microsoft.com/office/drawing/2014/main" id="{0B1B5A94-32DB-49C9-8F87-A8AC9734B6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="" xmlns:a16="http://schemas.microsoft.com/office/drawing/2014/main" id="{F011D4F3-80BC-4495-A783-7B03ACCF1F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="" xmlns:a16="http://schemas.microsoft.com/office/drawing/2014/main" id="{7BF56FCF-DE83-434C-A4C8-FC7FFBCAE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="" xmlns:a16="http://schemas.microsoft.com/office/drawing/2014/main" id="{B17D8401-854F-4676-A9F2-7DF084A53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="" xmlns:a16="http://schemas.microsoft.com/office/drawing/2014/main" id="{E31C2738-3990-48E6-B0D4-E1CC2746E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7787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="" xmlns:a16="http://schemas.microsoft.com/office/drawing/2014/main" id="{D8AF769D-501C-47D4-A533-EA7340D9C2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="" xmlns:a16="http://schemas.microsoft.com/office/drawing/2014/main" id="{15652FD5-BC2E-4265-A75A-394740E8AF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="" xmlns:a16="http://schemas.microsoft.com/office/drawing/2014/main" id="{62E3E8DA-54DD-48DB-AC52-9489BD70DF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9B9C67-6581-4CD8-8E17-9CD65A7D767B}" type="datetimeFigureOut">
              <a:rPr lang="de-DE" smtClean="0"/>
              <a:t>14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="" xmlns:a16="http://schemas.microsoft.com/office/drawing/2014/main" id="{A4B342CC-9358-4056-8A56-125AD8BC74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="" xmlns:a16="http://schemas.microsoft.com/office/drawing/2014/main" id="{AC8FD3E6-D7BC-4858-A297-8F38031646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D7432C-9B62-4CAC-88E9-A041BC45C6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6235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Tabelle 14">
            <a:extLst>
              <a:ext uri="{FF2B5EF4-FFF2-40B4-BE49-F238E27FC236}">
                <a16:creationId xmlns="" xmlns:a16="http://schemas.microsoft.com/office/drawing/2014/main" id="{407BEDF3-9589-4E4D-A036-39848861A4E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8698601"/>
              </p:ext>
            </p:extLst>
          </p:nvPr>
        </p:nvGraphicFramePr>
        <p:xfrm>
          <a:off x="1201964" y="225692"/>
          <a:ext cx="9596664" cy="6235583"/>
        </p:xfrm>
        <a:graphic>
          <a:graphicData uri="http://schemas.openxmlformats.org/drawingml/2006/table">
            <a:tbl>
              <a:tblPr firstRow="1" firstCol="1" bandRow="1">
                <a:tableStyleId>{E8034E78-7F5D-4C2E-B375-FC64B27BC917}</a:tableStyleId>
              </a:tblPr>
              <a:tblGrid>
                <a:gridCol w="1250950">
                  <a:extLst>
                    <a:ext uri="{9D8B030D-6E8A-4147-A177-3AD203B41FA5}">
                      <a16:colId xmlns="" xmlns:a16="http://schemas.microsoft.com/office/drawing/2014/main" val="1053373155"/>
                    </a:ext>
                  </a:extLst>
                </a:gridCol>
                <a:gridCol w="1262743">
                  <a:extLst>
                    <a:ext uri="{9D8B030D-6E8A-4147-A177-3AD203B41FA5}">
                      <a16:colId xmlns="" xmlns:a16="http://schemas.microsoft.com/office/drawing/2014/main" val="7108406"/>
                    </a:ext>
                  </a:extLst>
                </a:gridCol>
                <a:gridCol w="1393372">
                  <a:extLst>
                    <a:ext uri="{9D8B030D-6E8A-4147-A177-3AD203B41FA5}">
                      <a16:colId xmlns="" xmlns:a16="http://schemas.microsoft.com/office/drawing/2014/main" val="2570405033"/>
                    </a:ext>
                  </a:extLst>
                </a:gridCol>
                <a:gridCol w="1255193">
                  <a:extLst>
                    <a:ext uri="{9D8B030D-6E8A-4147-A177-3AD203B41FA5}">
                      <a16:colId xmlns="" xmlns:a16="http://schemas.microsoft.com/office/drawing/2014/main" val="788499022"/>
                    </a:ext>
                  </a:extLst>
                </a:gridCol>
                <a:gridCol w="1473492">
                  <a:extLst>
                    <a:ext uri="{9D8B030D-6E8A-4147-A177-3AD203B41FA5}">
                      <a16:colId xmlns="" xmlns:a16="http://schemas.microsoft.com/office/drawing/2014/main" val="3145266147"/>
                    </a:ext>
                  </a:extLst>
                </a:gridCol>
                <a:gridCol w="1451429">
                  <a:extLst>
                    <a:ext uri="{9D8B030D-6E8A-4147-A177-3AD203B41FA5}">
                      <a16:colId xmlns="" xmlns:a16="http://schemas.microsoft.com/office/drawing/2014/main" val="4027734315"/>
                    </a:ext>
                  </a:extLst>
                </a:gridCol>
                <a:gridCol w="1509485">
                  <a:extLst>
                    <a:ext uri="{9D8B030D-6E8A-4147-A177-3AD203B41FA5}">
                      <a16:colId xmlns="" xmlns:a16="http://schemas.microsoft.com/office/drawing/2014/main" val="3939721293"/>
                    </a:ext>
                  </a:extLst>
                </a:gridCol>
              </a:tblGrid>
              <a:tr h="41760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900" noProof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i="1" noProof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 vitro </a:t>
                      </a:r>
                      <a:r>
                        <a:rPr lang="en-US" sz="900" noProof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 2D</a:t>
                      </a:r>
                      <a:endParaRPr lang="en-US" sz="900" noProof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3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                                                       </a:t>
                      </a:r>
                      <a:r>
                        <a:rPr lang="en-US" sz="900" i="1" noProof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 vitro </a:t>
                      </a:r>
                      <a:r>
                        <a:rPr lang="en-US" sz="900" noProof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 3D</a:t>
                      </a:r>
                      <a:endParaRPr lang="en-US" sz="900" noProof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1000" noProof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i="1" noProof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 vivo</a:t>
                      </a:r>
                      <a:endParaRPr lang="en-US" sz="900" i="1" noProof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i="1" noProof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</a:t>
                      </a:r>
                      <a:r>
                        <a:rPr lang="en-US" sz="900" i="1" baseline="0" noProof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vivo</a:t>
                      </a:r>
                      <a:endParaRPr lang="en-US" sz="900" i="1" noProof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26155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noProof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models</a:t>
                      </a:r>
                      <a:endParaRPr lang="en-US" sz="900" b="1" noProof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noProof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heroids</a:t>
                      </a:r>
                      <a:endParaRPr lang="en-US" sz="900" b="1" noProof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noProof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O</a:t>
                      </a:r>
                      <a:endParaRPr lang="en-US" sz="900" b="1" noProof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noProof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OC</a:t>
                      </a:r>
                      <a:endParaRPr lang="en-US" sz="900" b="1" noProof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noProof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SC</a:t>
                      </a:r>
                      <a:endParaRPr lang="en-US" sz="900" b="1" noProof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noProof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DX</a:t>
                      </a:r>
                      <a:endParaRPr lang="en-US" sz="900" b="1" noProof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465870750"/>
                  </a:ext>
                </a:extLst>
              </a:tr>
              <a:tr h="52502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cell heterogeneity</a:t>
                      </a:r>
                      <a:endParaRPr lang="en-US" sz="900" noProof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mited for established cell lines</a:t>
                      </a: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mited for established cell lines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Wingdings" panose="05000000000000000000" pitchFamily="2" charset="2"/>
                        </a:rPr>
                        <a:t>improved</a:t>
                      </a:r>
                      <a:endParaRPr lang="en-US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mprove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igh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igh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="" xmlns:a16="http://schemas.microsoft.com/office/drawing/2014/main" val="3588362631"/>
                  </a:ext>
                </a:extLst>
              </a:tr>
              <a:tr h="15639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croenvironment</a:t>
                      </a: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CM has to be exogenously added,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direct &amp; direct co-cultures with allogeneic immune or stroma cell populations possibl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CM has to be exogenously added,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rect co-cultures with allogeneic immune or stroma cell populations possible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CM has to be exogenously added,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direct &amp; direct co-cultures with allogeneic (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utologeous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 immune or stroma cell populations possibl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CM has to be exogenously added,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direct &amp; direct co-cultures with allogeneic (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utologeous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 immune or stroma cell populations possibl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mpletely preserved for distinct time  (depending on tumor entity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mpletely preserved for distinct time, 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version into murine strom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="" xmlns:a16="http://schemas.microsoft.com/office/drawing/2014/main" val="3049798971"/>
                  </a:ext>
                </a:extLst>
              </a:tr>
              <a:tr h="62557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trient/oxygen gradient </a:t>
                      </a:r>
                      <a:r>
                        <a:rPr lang="en-US" sz="900" noProof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amp; </a:t>
                      </a:r>
                      <a:r>
                        <a:rPr lang="en-US" sz="900" noProof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scularization</a:t>
                      </a:r>
                      <a:endParaRPr lang="en-US" sz="900" noProof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ssing</a:t>
                      </a: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ypoxic zone in spheroid core, 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ack </a:t>
                      </a:r>
                      <a:r>
                        <a:rPr lang="en-US" sz="900" noProof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en-US" sz="900" baseline="0" noProof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noProof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ascularization</a:t>
                      </a:r>
                      <a:endParaRPr lang="en-US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ssin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sibl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utrient &amp; oxygen gradient observed,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ack of </a:t>
                      </a:r>
                      <a:r>
                        <a:rPr lang="en-US" sz="900" noProof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ascularization </a:t>
                      </a:r>
                      <a:endParaRPr lang="en-US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esen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="" xmlns:a16="http://schemas.microsoft.com/office/drawing/2014/main" val="2693111169"/>
                  </a:ext>
                </a:extLst>
              </a:tr>
              <a:tr h="43249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del establishment</a:t>
                      </a: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ast</a:t>
                      </a: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ast 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ime consumin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ime consumin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as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ime consumin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="" xmlns:a16="http://schemas.microsoft.com/office/drawing/2014/main" val="1446456994"/>
                  </a:ext>
                </a:extLst>
              </a:tr>
              <a:tr h="35001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roducibility </a:t>
                      </a:r>
                      <a:endParaRPr lang="en-US" sz="900" noProof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igh</a:t>
                      </a: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ariabl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900" noProof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tient-dependen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ariabl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tient-dependen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tient-dependen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="" xmlns:a16="http://schemas.microsoft.com/office/drawing/2014/main" val="2715127592"/>
                  </a:ext>
                </a:extLst>
              </a:tr>
              <a:tr h="39397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throughput screening</a:t>
                      </a:r>
                      <a:endParaRPr lang="en-US" sz="900" noProof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sible</a:t>
                      </a: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sible 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sibl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mite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mite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mite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="" xmlns:a16="http://schemas.microsoft.com/office/drawing/2014/main" val="1313923211"/>
                  </a:ext>
                </a:extLst>
              </a:tr>
              <a:tr h="166540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noProof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ting of immunotherapies*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900" noProof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CI (12) </a:t>
                      </a:r>
                      <a:endParaRPr lang="de-DE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Bispecific antibodies (24, 25) </a:t>
                      </a:r>
                      <a:endParaRPr lang="de-DE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CAR T cells (1)</a:t>
                      </a:r>
                      <a:endParaRPr lang="de-DE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Oncolytic viruses (14)</a:t>
                      </a:r>
                      <a:endParaRPr lang="de-DE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8735" marR="38735" marT="9525" marB="0"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CAR-NK cells (46)</a:t>
                      </a:r>
                      <a:endParaRPr lang="de-DE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CI (41)</a:t>
                      </a:r>
                      <a:endParaRPr lang="de-DE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Macrophage activation (47)</a:t>
                      </a:r>
                      <a:endParaRPr lang="de-DE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8735" marR="38735" marT="9525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Therapy prediction </a:t>
                      </a: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(60, 77, 78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CI (7–9, 71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Bispecific antibodies (65) 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CAR T cells (73, 74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900" kern="120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136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TIL (67, 72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8735" marR="38735" marT="9525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CI (10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AR T cells (</a:t>
                      </a:r>
                      <a:r>
                        <a:rPr lang="en-US" sz="9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20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8735" marR="38735" marT="9525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Drug </a:t>
                      </a: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testing &amp; development (</a:t>
                      </a: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121, 122, 135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CI (13, </a:t>
                      </a: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122) 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8735" marR="38735" marT="9525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Therapy </a:t>
                      </a: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prediction (83, 99, </a:t>
                      </a: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110–112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CAR T cells (2–4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CI (6, 11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6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TIL (5) 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8735" marR="38735" marT="9525" marB="0">
                    <a:lnL w="12700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="" xmlns:a16="http://schemas.microsoft.com/office/drawing/2014/main" val="38110237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71781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0</Words>
  <Application>Microsoft Office PowerPoint</Application>
  <PresentationFormat>Benutzerdefiniert</PresentationFormat>
  <Paragraphs>8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aum 9 PC 3</dc:creator>
  <cp:lastModifiedBy>Sebens</cp:lastModifiedBy>
  <cp:revision>34</cp:revision>
  <dcterms:created xsi:type="dcterms:W3CDTF">2023-07-06T08:11:45Z</dcterms:created>
  <dcterms:modified xsi:type="dcterms:W3CDTF">2023-07-14T12:26:25Z</dcterms:modified>
</cp:coreProperties>
</file>